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4" r:id="rId2"/>
    <p:sldId id="258" r:id="rId3"/>
    <p:sldId id="263" r:id="rId4"/>
    <p:sldId id="264" r:id="rId5"/>
    <p:sldId id="281" r:id="rId6"/>
    <p:sldId id="27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89E7134-FA69-4CC6-A2D7-0033A33F2B8F}" v="4" dt="2023-01-11T11:14:07.90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11" autoAdjust="0"/>
    <p:restoredTop sz="94660"/>
  </p:normalViewPr>
  <p:slideViewPr>
    <p:cSldViewPr snapToGrid="0">
      <p:cViewPr varScale="1">
        <p:scale>
          <a:sx n="78" d="100"/>
          <a:sy n="78" d="100"/>
        </p:scale>
        <p:origin x="116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inor Chapman (Staff)" userId="223bbccc-7b70-4cb9-8d7f-1546dfbed267" providerId="ADAL" clId="{489E7134-FA69-4CC6-A2D7-0033A33F2B8F}"/>
    <pc:docChg chg="undo custSel modSld">
      <pc:chgData name="Elinor Chapman (Staff)" userId="223bbccc-7b70-4cb9-8d7f-1546dfbed267" providerId="ADAL" clId="{489E7134-FA69-4CC6-A2D7-0033A33F2B8F}" dt="2023-01-11T11:22:28.830" v="105" actId="20577"/>
      <pc:docMkLst>
        <pc:docMk/>
      </pc:docMkLst>
      <pc:sldChg chg="modSp mod">
        <pc:chgData name="Elinor Chapman (Staff)" userId="223bbccc-7b70-4cb9-8d7f-1546dfbed267" providerId="ADAL" clId="{489E7134-FA69-4CC6-A2D7-0033A33F2B8F}" dt="2023-01-11T11:22:28.830" v="105" actId="20577"/>
        <pc:sldMkLst>
          <pc:docMk/>
          <pc:sldMk cId="3311177837" sldId="263"/>
        </pc:sldMkLst>
        <pc:spChg chg="mod">
          <ac:chgData name="Elinor Chapman (Staff)" userId="223bbccc-7b70-4cb9-8d7f-1546dfbed267" providerId="ADAL" clId="{489E7134-FA69-4CC6-A2D7-0033A33F2B8F}" dt="2023-01-11T11:22:28.830" v="105" actId="20577"/>
          <ac:spMkLst>
            <pc:docMk/>
            <pc:sldMk cId="3311177837" sldId="263"/>
            <ac:spMk id="4" creationId="{3408F402-C8FC-4AB9-AFEC-1F59AFDE6609}"/>
          </ac:spMkLst>
        </pc:spChg>
      </pc:sldChg>
      <pc:sldChg chg="addSp delSp modSp mod">
        <pc:chgData name="Elinor Chapman (Staff)" userId="223bbccc-7b70-4cb9-8d7f-1546dfbed267" providerId="ADAL" clId="{489E7134-FA69-4CC6-A2D7-0033A33F2B8F}" dt="2023-01-11T11:14:45.609" v="98" actId="208"/>
        <pc:sldMkLst>
          <pc:docMk/>
          <pc:sldMk cId="827355013" sldId="281"/>
        </pc:sldMkLst>
        <pc:spChg chg="mod">
          <ac:chgData name="Elinor Chapman (Staff)" userId="223bbccc-7b70-4cb9-8d7f-1546dfbed267" providerId="ADAL" clId="{489E7134-FA69-4CC6-A2D7-0033A33F2B8F}" dt="2023-01-11T11:13:02.098" v="64" actId="14100"/>
          <ac:spMkLst>
            <pc:docMk/>
            <pc:sldMk cId="827355013" sldId="281"/>
            <ac:spMk id="5" creationId="{94157E2A-7322-4188-978F-A69A269C0FAB}"/>
          </ac:spMkLst>
        </pc:spChg>
        <pc:spChg chg="mod">
          <ac:chgData name="Elinor Chapman (Staff)" userId="223bbccc-7b70-4cb9-8d7f-1546dfbed267" providerId="ADAL" clId="{489E7134-FA69-4CC6-A2D7-0033A33F2B8F}" dt="2023-01-11T11:13:02.098" v="64" actId="14100"/>
          <ac:spMkLst>
            <pc:docMk/>
            <pc:sldMk cId="827355013" sldId="281"/>
            <ac:spMk id="6" creationId="{79C2FF46-90A1-4270-801A-87EF00FC09E1}"/>
          </ac:spMkLst>
        </pc:spChg>
        <pc:spChg chg="mod">
          <ac:chgData name="Elinor Chapman (Staff)" userId="223bbccc-7b70-4cb9-8d7f-1546dfbed267" providerId="ADAL" clId="{489E7134-FA69-4CC6-A2D7-0033A33F2B8F}" dt="2023-01-11T11:13:02.098" v="64" actId="14100"/>
          <ac:spMkLst>
            <pc:docMk/>
            <pc:sldMk cId="827355013" sldId="281"/>
            <ac:spMk id="7" creationId="{4BBDA365-20E1-4C68-8DEB-C07026694853}"/>
          </ac:spMkLst>
        </pc:spChg>
        <pc:spChg chg="mod">
          <ac:chgData name="Elinor Chapman (Staff)" userId="223bbccc-7b70-4cb9-8d7f-1546dfbed267" providerId="ADAL" clId="{489E7134-FA69-4CC6-A2D7-0033A33F2B8F}" dt="2023-01-11T11:13:02.098" v="64" actId="14100"/>
          <ac:spMkLst>
            <pc:docMk/>
            <pc:sldMk cId="827355013" sldId="281"/>
            <ac:spMk id="8" creationId="{14A2B67A-DDDD-4BE7-B019-EF0238F856AC}"/>
          </ac:spMkLst>
        </pc:spChg>
        <pc:spChg chg="mod">
          <ac:chgData name="Elinor Chapman (Staff)" userId="223bbccc-7b70-4cb9-8d7f-1546dfbed267" providerId="ADAL" clId="{489E7134-FA69-4CC6-A2D7-0033A33F2B8F}" dt="2023-01-11T11:13:02.098" v="64" actId="14100"/>
          <ac:spMkLst>
            <pc:docMk/>
            <pc:sldMk cId="827355013" sldId="281"/>
            <ac:spMk id="9" creationId="{08DE2696-3BC8-4881-A8E4-8B99CBDF36B0}"/>
          </ac:spMkLst>
        </pc:spChg>
        <pc:spChg chg="mod">
          <ac:chgData name="Elinor Chapman (Staff)" userId="223bbccc-7b70-4cb9-8d7f-1546dfbed267" providerId="ADAL" clId="{489E7134-FA69-4CC6-A2D7-0033A33F2B8F}" dt="2023-01-11T11:13:02.098" v="64" actId="14100"/>
          <ac:spMkLst>
            <pc:docMk/>
            <pc:sldMk cId="827355013" sldId="281"/>
            <ac:spMk id="10" creationId="{36F67ED6-8765-4005-AC73-6ACD7BC128F4}"/>
          </ac:spMkLst>
        </pc:spChg>
        <pc:spChg chg="mod">
          <ac:chgData name="Elinor Chapman (Staff)" userId="223bbccc-7b70-4cb9-8d7f-1546dfbed267" providerId="ADAL" clId="{489E7134-FA69-4CC6-A2D7-0033A33F2B8F}" dt="2023-01-11T11:13:02.098" v="64" actId="14100"/>
          <ac:spMkLst>
            <pc:docMk/>
            <pc:sldMk cId="827355013" sldId="281"/>
            <ac:spMk id="11" creationId="{F97AA3DE-C5DE-45F1-AA30-948499354EF1}"/>
          </ac:spMkLst>
        </pc:spChg>
        <pc:spChg chg="mod">
          <ac:chgData name="Elinor Chapman (Staff)" userId="223bbccc-7b70-4cb9-8d7f-1546dfbed267" providerId="ADAL" clId="{489E7134-FA69-4CC6-A2D7-0033A33F2B8F}" dt="2023-01-11T11:13:02.098" v="64" actId="14100"/>
          <ac:spMkLst>
            <pc:docMk/>
            <pc:sldMk cId="827355013" sldId="281"/>
            <ac:spMk id="12" creationId="{04124089-228B-40FD-8BB7-A010AC7C8887}"/>
          </ac:spMkLst>
        </pc:spChg>
        <pc:spChg chg="add del mod">
          <ac:chgData name="Elinor Chapman (Staff)" userId="223bbccc-7b70-4cb9-8d7f-1546dfbed267" providerId="ADAL" clId="{489E7134-FA69-4CC6-A2D7-0033A33F2B8F}" dt="2023-01-11T11:12:30.898" v="54" actId="478"/>
          <ac:spMkLst>
            <pc:docMk/>
            <pc:sldMk cId="827355013" sldId="281"/>
            <ac:spMk id="13" creationId="{CE40C1F9-B159-4012-AD87-19D2201ED6D3}"/>
          </ac:spMkLst>
        </pc:spChg>
        <pc:spChg chg="mod">
          <ac:chgData name="Elinor Chapman (Staff)" userId="223bbccc-7b70-4cb9-8d7f-1546dfbed267" providerId="ADAL" clId="{489E7134-FA69-4CC6-A2D7-0033A33F2B8F}" dt="2023-01-11T11:13:14.073" v="69" actId="20577"/>
          <ac:spMkLst>
            <pc:docMk/>
            <pc:sldMk cId="827355013" sldId="281"/>
            <ac:spMk id="14" creationId="{F6503E7A-94DE-47E5-9581-768FA324F887}"/>
          </ac:spMkLst>
        </pc:spChg>
        <pc:spChg chg="add mod">
          <ac:chgData name="Elinor Chapman (Staff)" userId="223bbccc-7b70-4cb9-8d7f-1546dfbed267" providerId="ADAL" clId="{489E7134-FA69-4CC6-A2D7-0033A33F2B8F}" dt="2023-01-11T11:14:07.903" v="92" actId="164"/>
          <ac:spMkLst>
            <pc:docMk/>
            <pc:sldMk cId="827355013" sldId="281"/>
            <ac:spMk id="15" creationId="{848BFB4C-4B5C-4FE3-B12C-211C7338A82F}"/>
          </ac:spMkLst>
        </pc:spChg>
        <pc:spChg chg="add mod">
          <ac:chgData name="Elinor Chapman (Staff)" userId="223bbccc-7b70-4cb9-8d7f-1546dfbed267" providerId="ADAL" clId="{489E7134-FA69-4CC6-A2D7-0033A33F2B8F}" dt="2023-01-11T11:14:07.903" v="92" actId="164"/>
          <ac:spMkLst>
            <pc:docMk/>
            <pc:sldMk cId="827355013" sldId="281"/>
            <ac:spMk id="16" creationId="{1A5577DF-F8CD-41DA-9610-BD1AFD08477D}"/>
          </ac:spMkLst>
        </pc:spChg>
        <pc:spChg chg="add mod">
          <ac:chgData name="Elinor Chapman (Staff)" userId="223bbccc-7b70-4cb9-8d7f-1546dfbed267" providerId="ADAL" clId="{489E7134-FA69-4CC6-A2D7-0033A33F2B8F}" dt="2023-01-11T11:14:07.903" v="92" actId="164"/>
          <ac:spMkLst>
            <pc:docMk/>
            <pc:sldMk cId="827355013" sldId="281"/>
            <ac:spMk id="17" creationId="{2932B42D-8079-4077-A738-740C0F652283}"/>
          </ac:spMkLst>
        </pc:spChg>
        <pc:spChg chg="add mod">
          <ac:chgData name="Elinor Chapman (Staff)" userId="223bbccc-7b70-4cb9-8d7f-1546dfbed267" providerId="ADAL" clId="{489E7134-FA69-4CC6-A2D7-0033A33F2B8F}" dt="2023-01-11T11:14:45.609" v="98" actId="208"/>
          <ac:spMkLst>
            <pc:docMk/>
            <pc:sldMk cId="827355013" sldId="281"/>
            <ac:spMk id="18" creationId="{9AFBC03E-E5D8-48B8-BD1C-0C6B78E4B8D1}"/>
          </ac:spMkLst>
        </pc:spChg>
        <pc:grpChg chg="add mod">
          <ac:chgData name="Elinor Chapman (Staff)" userId="223bbccc-7b70-4cb9-8d7f-1546dfbed267" providerId="ADAL" clId="{489E7134-FA69-4CC6-A2D7-0033A33F2B8F}" dt="2023-01-11T11:14:07.903" v="92" actId="164"/>
          <ac:grpSpMkLst>
            <pc:docMk/>
            <pc:sldMk cId="827355013" sldId="281"/>
            <ac:grpSpMk id="3" creationId="{DF68A58A-F375-48C4-88C3-ECB214FE2D20}"/>
          </ac:grpSpMkLst>
        </pc:grpChg>
        <pc:picChg chg="mod">
          <ac:chgData name="Elinor Chapman (Staff)" userId="223bbccc-7b70-4cb9-8d7f-1546dfbed267" providerId="ADAL" clId="{489E7134-FA69-4CC6-A2D7-0033A33F2B8F}" dt="2023-01-11T11:13:02.098" v="64" actId="14100"/>
          <ac:picMkLst>
            <pc:docMk/>
            <pc:sldMk cId="827355013" sldId="281"/>
            <ac:picMk id="4" creationId="{FF81CE59-C64F-4E4F-83DB-CEEC40D0950E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nc20nlh\Dropbox\ShinyApp1\ACID\ACID_Thresholding\OUTPUTFORPAPER\fulllist_down_23_merg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nc20nlh\Dropbox\ShinyApp1\ACID\ACID_Thresholding\OUTPUTFORPAPER\fulllist_up_14_merge_edi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fulllist_down_23_merge.xlsx]Sheet1!PivotTable10</c:name>
    <c:fmtId val="-1"/>
  </c:pivotSource>
  <c:chart>
    <c:autoTitleDeleted val="1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Tot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4:$A$10</c:f>
              <c:strCache>
                <c:ptCount val="7"/>
                <c:pt idx="0">
                  <c:v>Alcohol</c:v>
                </c:pt>
                <c:pt idx="1">
                  <c:v>Benzene derivative</c:v>
                </c:pt>
                <c:pt idx="2">
                  <c:v>Cosmetic</c:v>
                </c:pt>
                <c:pt idx="3">
                  <c:v>Heterocyclic compound</c:v>
                </c:pt>
                <c:pt idx="4">
                  <c:v>Hydrocarbon</c:v>
                </c:pt>
                <c:pt idx="5">
                  <c:v>Sulphur compound</c:v>
                </c:pt>
                <c:pt idx="6">
                  <c:v>Unclassified</c:v>
                </c:pt>
              </c:strCache>
            </c:strRef>
          </c:cat>
          <c:val>
            <c:numRef>
              <c:f>Sheet1!$B$4:$B$10</c:f>
              <c:numCache>
                <c:formatCode>General</c:formatCode>
                <c:ptCount val="7"/>
                <c:pt idx="0">
                  <c:v>3</c:v>
                </c:pt>
                <c:pt idx="1">
                  <c:v>2</c:v>
                </c:pt>
                <c:pt idx="2">
                  <c:v>1</c:v>
                </c:pt>
                <c:pt idx="3">
                  <c:v>2</c:v>
                </c:pt>
                <c:pt idx="4">
                  <c:v>6</c:v>
                </c:pt>
                <c:pt idx="5">
                  <c:v>1</c:v>
                </c:pt>
                <c:pt idx="6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4B-440B-9BC6-9EAD678E8C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499721320"/>
        <c:axId val="499719024"/>
      </c:barChart>
      <c:catAx>
        <c:axId val="4997213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9719024"/>
        <c:crosses val="autoZero"/>
        <c:auto val="1"/>
        <c:lblAlgn val="ctr"/>
        <c:lblOffset val="100"/>
        <c:noMultiLvlLbl val="0"/>
      </c:catAx>
      <c:valAx>
        <c:axId val="4997190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99721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Visible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pivotSource>
    <c:name>[fulllist_up_14_merge_edit.xlsx]Sheet2!PivotTable5</c:name>
    <c:fmtId val="-1"/>
  </c:pivotSource>
  <c:chart>
    <c:autoTitleDeleted val="1"/>
    <c:pivotFmts>
      <c:pivotFmt>
        <c:idx val="0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1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  <c:pivotFmt>
        <c:idx val="2"/>
        <c:spPr>
          <a:solidFill>
            <a:schemeClr val="accent1"/>
          </a:solidFill>
          <a:ln>
            <a:noFill/>
          </a:ln>
          <a:effectLst/>
        </c:spPr>
        <c:marker>
          <c:symbol val="none"/>
        </c:marker>
        <c:dLbl>
          <c:idx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lIns="38100" tIns="19050" rIns="38100" bIns="19050" anchor="ctr" anchorCtr="1">
              <a:spAutoFit/>
            </a:bodyPr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  <c:showLegendKey val="0"/>
          <c:showVal val="0"/>
          <c:showCatName val="0"/>
          <c:showSerName val="0"/>
          <c:showPercent val="0"/>
          <c:showBubbleSize val="0"/>
          <c:extLst>
            <c:ext xmlns:c15="http://schemas.microsoft.com/office/drawing/2012/chart" uri="{CE6537A1-D6FC-4f65-9D91-7224C49458BB}"/>
          </c:extLst>
        </c:dLbl>
      </c:pivotFmt>
    </c:pivotFmts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B$3</c:f>
              <c:strCache>
                <c:ptCount val="1"/>
                <c:pt idx="0">
                  <c:v>Tot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A$4:$A$11</c:f>
              <c:strCache>
                <c:ptCount val="8"/>
                <c:pt idx="0">
                  <c:v>Aldehyde</c:v>
                </c:pt>
                <c:pt idx="1">
                  <c:v>Amine</c:v>
                </c:pt>
                <c:pt idx="2">
                  <c:v>Benzene derivative</c:v>
                </c:pt>
                <c:pt idx="3">
                  <c:v>Carboxylic acid</c:v>
                </c:pt>
                <c:pt idx="4">
                  <c:v>Heterocyclic compound</c:v>
                </c:pt>
                <c:pt idx="5">
                  <c:v>Ketone</c:v>
                </c:pt>
                <c:pt idx="6">
                  <c:v>Lipid</c:v>
                </c:pt>
                <c:pt idx="7">
                  <c:v>Unclassified</c:v>
                </c:pt>
              </c:strCache>
            </c:strRef>
          </c:cat>
          <c:val>
            <c:numRef>
              <c:f>Sheet2!$B$4:$B$11</c:f>
              <c:numCache>
                <c:formatCode>General</c:formatCode>
                <c:ptCount val="8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6</c:v>
                </c:pt>
                <c:pt idx="6">
                  <c:v>1</c:v>
                </c:pt>
                <c:pt idx="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44-447D-B575-F26B6C1830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683438160"/>
        <c:axId val="683438488"/>
      </c:barChart>
      <c:catAx>
        <c:axId val="6834381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83438488"/>
        <c:crosses val="autoZero"/>
        <c:auto val="1"/>
        <c:lblAlgn val="ctr"/>
        <c:lblOffset val="100"/>
        <c:noMultiLvlLbl val="0"/>
      </c:catAx>
      <c:valAx>
        <c:axId val="6834384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83438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extLst>
    <c:ext xmlns:c14="http://schemas.microsoft.com/office/drawing/2007/8/2/chart" uri="{781A3756-C4B2-4CAC-9D66-4F8BD8637D16}">
      <c14:pivotOptions>
        <c14:dropZoneFilter val="1"/>
        <c14:dropZoneCategories val="1"/>
        <c14:dropZoneData val="1"/>
        <c14:dropZonesVisible val="1"/>
      </c14:pivotOptions>
    </c:ext>
    <c:ext xmlns:c16="http://schemas.microsoft.com/office/drawing/2014/chart" uri="{E28EC0CA-F0BB-4C9C-879D-F8772B89E7AC}">
      <c16:pivotOptions16>
        <c16:showExpandCollapseFieldButtons val="1"/>
      </c16:pivotOptions16>
    </c:ext>
  </c:extLst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7402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2633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7971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0556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0031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2941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8364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1265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5480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5425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1547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193972-63CF-4AE2-99BA-BF10538DEF8C}" type="datetimeFigureOut">
              <a:rPr lang="en-GB" smtClean="0"/>
              <a:t>1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03F7AE-C36C-4E6B-AAED-5984E4B90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3557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picture containing dark&#10;&#10;Description automatically generated">
            <a:extLst>
              <a:ext uri="{FF2B5EF4-FFF2-40B4-BE49-F238E27FC236}">
                <a16:creationId xmlns:a16="http://schemas.microsoft.com/office/drawing/2014/main" id="{39F80D44-29BB-4827-9E73-CAC6CAEECB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593" y="1815882"/>
            <a:ext cx="6400813" cy="640081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C871344-6CBB-4D7A-B679-05277A56767E}"/>
              </a:ext>
            </a:extLst>
          </p:cNvPr>
          <p:cNvSpPr txBox="1"/>
          <p:nvPr/>
        </p:nvSpPr>
        <p:spPr>
          <a:xfrm>
            <a:off x="1" y="0"/>
            <a:ext cx="685800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: Volcano plot of all VOCs significantly changed towards death.</a:t>
            </a:r>
            <a:b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BH.pvals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benjamini-hochberg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corrected p-value</a:t>
            </a:r>
            <a:b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C = fold-change</a:t>
            </a:r>
            <a:b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Labels are retention time (RT) labels.</a:t>
            </a:r>
          </a:p>
          <a:p>
            <a:r>
              <a:rPr lang="en-GB" sz="14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2-fold change, p&lt;0.05 shown in green dots</a:t>
            </a:r>
          </a:p>
          <a:p>
            <a:r>
              <a:rPr lang="en-GB" sz="14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2-fold change, p&lt;0.06 shown in blue dots</a:t>
            </a:r>
          </a:p>
          <a:p>
            <a:r>
              <a:rPr lang="en-GB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&lt;0.05 shown in red dots</a:t>
            </a:r>
          </a:p>
          <a:p>
            <a:r>
              <a:rPr lang="en-GB" sz="1400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2-fold change shown in orange dots.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32964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Chart, bubble chart&#10;&#10;Description automatically generated">
            <a:extLst>
              <a:ext uri="{FF2B5EF4-FFF2-40B4-BE49-F238E27FC236}">
                <a16:creationId xmlns:a16="http://schemas.microsoft.com/office/drawing/2014/main" id="{4558D048-E87A-4D76-A2DD-D61D615780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07777"/>
            <a:ext cx="6857999" cy="685799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9609C961-4E3D-40EF-BCFA-A717CD775D93}"/>
              </a:ext>
            </a:extLst>
          </p:cNvPr>
          <p:cNvSpPr txBox="1"/>
          <p:nvPr/>
        </p:nvSpPr>
        <p:spPr>
          <a:xfrm>
            <a:off x="1" y="0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: </a:t>
            </a:r>
            <a:r>
              <a:rPr lang="en-GB" sz="14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. PLSDA plot of acid dataset by Week.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71274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9D057DB7-EC7E-4E2B-A38F-FA81EE7253B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679119919"/>
              </p:ext>
            </p:extLst>
          </p:nvPr>
        </p:nvGraphicFramePr>
        <p:xfrm>
          <a:off x="563246" y="5286633"/>
          <a:ext cx="5731510" cy="22059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995506D0-EC39-4B57-9DDB-6DD27211056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177648052"/>
              </p:ext>
            </p:extLst>
          </p:nvPr>
        </p:nvGraphicFramePr>
        <p:xfrm>
          <a:off x="563246" y="1901648"/>
          <a:ext cx="5731510" cy="24307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408F402-C8FC-4AB9-AFEC-1F59AFDE6609}"/>
              </a:ext>
            </a:extLst>
          </p:cNvPr>
          <p:cNvSpPr txBox="1"/>
          <p:nvPr/>
        </p:nvSpPr>
        <p:spPr>
          <a:xfrm>
            <a:off x="0" y="0"/>
            <a:ext cx="6858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: Classification of VOCs changed toward death in acid dataset.</a:t>
            </a:r>
            <a:b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VOCs were classified using a combination of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MeSH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ChEBI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classification, as published previously [24].</a:t>
            </a:r>
          </a:p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. Count of VOCs increased towards death.</a:t>
            </a:r>
            <a:b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. Count of VOCs decreased towards death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70A0CD7-AF05-4E5D-B93C-B5BDCFC2E35C}"/>
              </a:ext>
            </a:extLst>
          </p:cNvPr>
          <p:cNvSpPr txBox="1"/>
          <p:nvPr/>
        </p:nvSpPr>
        <p:spPr>
          <a:xfrm>
            <a:off x="20024" y="1294838"/>
            <a:ext cx="7970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A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BFA1D24-D351-46A5-96D7-D391A014CD1C}"/>
              </a:ext>
            </a:extLst>
          </p:cNvPr>
          <p:cNvSpPr txBox="1"/>
          <p:nvPr/>
        </p:nvSpPr>
        <p:spPr>
          <a:xfrm>
            <a:off x="0" y="4624864"/>
            <a:ext cx="7970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B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3D610C5-00AA-4407-83BB-609C4CAFFE86}"/>
              </a:ext>
            </a:extLst>
          </p:cNvPr>
          <p:cNvSpPr txBox="1"/>
          <p:nvPr/>
        </p:nvSpPr>
        <p:spPr>
          <a:xfrm>
            <a:off x="1879919" y="4971851"/>
            <a:ext cx="441483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GB" b="1" dirty="0"/>
              <a:t>Count of VOCs Decreased</a:t>
            </a:r>
            <a:r>
              <a:rPr lang="en-GB" b="1" baseline="0" dirty="0"/>
              <a:t> towards deaths</a:t>
            </a:r>
            <a:endParaRPr lang="en-GB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1C9360D-5A6E-4DC8-8228-0C70E8A3034A}"/>
              </a:ext>
            </a:extLst>
          </p:cNvPr>
          <p:cNvSpPr txBox="1"/>
          <p:nvPr/>
        </p:nvSpPr>
        <p:spPr>
          <a:xfrm>
            <a:off x="1879918" y="1579861"/>
            <a:ext cx="441483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4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GB" b="1" dirty="0"/>
              <a:t>Count of VOCs Increased</a:t>
            </a:r>
            <a:r>
              <a:rPr lang="en-GB" b="1" baseline="0" dirty="0"/>
              <a:t> towards deaths</a:t>
            </a:r>
            <a:endParaRPr lang="en-GB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952FF3-C372-4D8E-88DE-68C04DE7CF95}"/>
              </a:ext>
            </a:extLst>
          </p:cNvPr>
          <p:cNvSpPr txBox="1"/>
          <p:nvPr/>
        </p:nvSpPr>
        <p:spPr>
          <a:xfrm rot="16200000">
            <a:off x="-865396" y="2863787"/>
            <a:ext cx="256785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MeSH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ChEBI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 classification </a:t>
            </a:r>
            <a:endParaRPr lang="en-GB"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72A376C-53D2-421E-A57E-3DCBDC99453D}"/>
              </a:ext>
            </a:extLst>
          </p:cNvPr>
          <p:cNvSpPr txBox="1"/>
          <p:nvPr/>
        </p:nvSpPr>
        <p:spPr>
          <a:xfrm rot="16200000">
            <a:off x="-833427" y="5979160"/>
            <a:ext cx="256785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MeSH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ChEBI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  classification 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3111778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3473B18-CF52-45CD-8F07-E2F06027BC9D}"/>
              </a:ext>
            </a:extLst>
          </p:cNvPr>
          <p:cNvSpPr txBox="1"/>
          <p:nvPr/>
        </p:nvSpPr>
        <p:spPr>
          <a:xfrm>
            <a:off x="0" y="-1"/>
            <a:ext cx="68579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: </a:t>
            </a:r>
            <a:r>
              <a:rPr lang="en-GB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libration curves for the 30 day Cox lasso regression model at days 14, 21 and </a:t>
            </a:r>
            <a:r>
              <a:rPr lang="en-GB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8</a:t>
            </a:r>
            <a:endParaRPr lang="en-GB" sz="14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297C0657-0C6B-4119-9CB4-9E25C6C2F3FC}"/>
              </a:ext>
            </a:extLst>
          </p:cNvPr>
          <p:cNvGrpSpPr/>
          <p:nvPr/>
        </p:nvGrpSpPr>
        <p:grpSpPr>
          <a:xfrm>
            <a:off x="1849095" y="261609"/>
            <a:ext cx="3159808" cy="9479425"/>
            <a:chOff x="5728648" y="-1610772"/>
            <a:chExt cx="4572000" cy="13716000"/>
          </a:xfrm>
        </p:grpSpPr>
        <p:pic>
          <p:nvPicPr>
            <p:cNvPr id="4" name="Picture 3" descr="Chart, line chart&#10;&#10;Description automatically generated">
              <a:extLst>
                <a:ext uri="{FF2B5EF4-FFF2-40B4-BE49-F238E27FC236}">
                  <a16:creationId xmlns:a16="http://schemas.microsoft.com/office/drawing/2014/main" id="{871F5244-806E-490A-8275-AC21A9243B7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28648" y="2961228"/>
              <a:ext cx="4572000" cy="4572000"/>
            </a:xfrm>
            <a:prstGeom prst="rect">
              <a:avLst/>
            </a:prstGeom>
          </p:spPr>
        </p:pic>
        <p:pic>
          <p:nvPicPr>
            <p:cNvPr id="7" name="Picture 6" descr="Chart, line chart&#10;&#10;Description automatically generated">
              <a:extLst>
                <a:ext uri="{FF2B5EF4-FFF2-40B4-BE49-F238E27FC236}">
                  <a16:creationId xmlns:a16="http://schemas.microsoft.com/office/drawing/2014/main" id="{DD89B03A-B492-45EB-B80B-A8E56931F52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28648" y="-1610772"/>
              <a:ext cx="4572000" cy="4572000"/>
            </a:xfrm>
            <a:prstGeom prst="rect">
              <a:avLst/>
            </a:prstGeom>
          </p:spPr>
        </p:pic>
        <p:pic>
          <p:nvPicPr>
            <p:cNvPr id="12" name="Picture 11" descr="Chart, line chart&#10;&#10;Description automatically generated">
              <a:extLst>
                <a:ext uri="{FF2B5EF4-FFF2-40B4-BE49-F238E27FC236}">
                  <a16:creationId xmlns:a16="http://schemas.microsoft.com/office/drawing/2014/main" id="{856F2773-78D0-455A-AE89-863EE2D85D7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28648" y="7533228"/>
              <a:ext cx="4572000" cy="4572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81335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alendar&#10;&#10;Description automatically generated with medium confidence">
            <a:extLst>
              <a:ext uri="{FF2B5EF4-FFF2-40B4-BE49-F238E27FC236}">
                <a16:creationId xmlns:a16="http://schemas.microsoft.com/office/drawing/2014/main" id="{FF81CE59-C64F-4E4F-83DB-CEEC40D095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823" y="777922"/>
            <a:ext cx="6454986" cy="9128078"/>
          </a:xfrm>
          <a:prstGeom prst="rect">
            <a:avLst/>
          </a:prstGeom>
        </p:spPr>
      </p:pic>
      <p:sp>
        <p:nvSpPr>
          <p:cNvPr id="5" name="Arrow: Down 4">
            <a:extLst>
              <a:ext uri="{FF2B5EF4-FFF2-40B4-BE49-F238E27FC236}">
                <a16:creationId xmlns:a16="http://schemas.microsoft.com/office/drawing/2014/main" id="{94157E2A-7322-4188-978F-A69A269C0FAB}"/>
              </a:ext>
            </a:extLst>
          </p:cNvPr>
          <p:cNvSpPr/>
          <p:nvPr/>
        </p:nvSpPr>
        <p:spPr>
          <a:xfrm>
            <a:off x="2174563" y="4049501"/>
            <a:ext cx="276548" cy="23796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79C2FF46-90A1-4270-801A-87EF00FC09E1}"/>
              </a:ext>
            </a:extLst>
          </p:cNvPr>
          <p:cNvSpPr/>
          <p:nvPr/>
        </p:nvSpPr>
        <p:spPr>
          <a:xfrm rot="10800000">
            <a:off x="2174563" y="1231629"/>
            <a:ext cx="276548" cy="237968"/>
          </a:xfrm>
          <a:prstGeom prst="downArrow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4BBDA365-20E1-4C68-8DEB-C07026694853}"/>
              </a:ext>
            </a:extLst>
          </p:cNvPr>
          <p:cNvSpPr/>
          <p:nvPr/>
        </p:nvSpPr>
        <p:spPr>
          <a:xfrm rot="10800000">
            <a:off x="4243338" y="1231630"/>
            <a:ext cx="276548" cy="237968"/>
          </a:xfrm>
          <a:prstGeom prst="downArrow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14A2B67A-DDDD-4BE7-B019-EF0238F856AC}"/>
              </a:ext>
            </a:extLst>
          </p:cNvPr>
          <p:cNvSpPr/>
          <p:nvPr/>
        </p:nvSpPr>
        <p:spPr>
          <a:xfrm rot="10800000">
            <a:off x="4243338" y="4037350"/>
            <a:ext cx="276548" cy="237968"/>
          </a:xfrm>
          <a:prstGeom prst="downArrow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Arrow: Down 8">
            <a:extLst>
              <a:ext uri="{FF2B5EF4-FFF2-40B4-BE49-F238E27FC236}">
                <a16:creationId xmlns:a16="http://schemas.microsoft.com/office/drawing/2014/main" id="{08DE2696-3BC8-4881-A8E4-8B99CBDF36B0}"/>
              </a:ext>
            </a:extLst>
          </p:cNvPr>
          <p:cNvSpPr/>
          <p:nvPr/>
        </p:nvSpPr>
        <p:spPr>
          <a:xfrm rot="10800000">
            <a:off x="6262079" y="3872697"/>
            <a:ext cx="276548" cy="237968"/>
          </a:xfrm>
          <a:prstGeom prst="downArrow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Arrow: Down 9">
            <a:extLst>
              <a:ext uri="{FF2B5EF4-FFF2-40B4-BE49-F238E27FC236}">
                <a16:creationId xmlns:a16="http://schemas.microsoft.com/office/drawing/2014/main" id="{36F67ED6-8765-4005-AC73-6ACD7BC128F4}"/>
              </a:ext>
            </a:extLst>
          </p:cNvPr>
          <p:cNvSpPr/>
          <p:nvPr/>
        </p:nvSpPr>
        <p:spPr>
          <a:xfrm>
            <a:off x="6262079" y="1231629"/>
            <a:ext cx="276548" cy="23796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Arrow: Down 10">
            <a:extLst>
              <a:ext uri="{FF2B5EF4-FFF2-40B4-BE49-F238E27FC236}">
                <a16:creationId xmlns:a16="http://schemas.microsoft.com/office/drawing/2014/main" id="{F97AA3DE-C5DE-45F1-AA30-948499354EF1}"/>
              </a:ext>
            </a:extLst>
          </p:cNvPr>
          <p:cNvSpPr/>
          <p:nvPr/>
        </p:nvSpPr>
        <p:spPr>
          <a:xfrm>
            <a:off x="2188211" y="6839688"/>
            <a:ext cx="276548" cy="23796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Arrow: Down 11">
            <a:extLst>
              <a:ext uri="{FF2B5EF4-FFF2-40B4-BE49-F238E27FC236}">
                <a16:creationId xmlns:a16="http://schemas.microsoft.com/office/drawing/2014/main" id="{04124089-228B-40FD-8BB7-A010AC7C8887}"/>
              </a:ext>
            </a:extLst>
          </p:cNvPr>
          <p:cNvSpPr/>
          <p:nvPr/>
        </p:nvSpPr>
        <p:spPr>
          <a:xfrm>
            <a:off x="4226008" y="6839688"/>
            <a:ext cx="276548" cy="23796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6503E7A-94DE-47E5-9581-768FA324F887}"/>
              </a:ext>
            </a:extLst>
          </p:cNvPr>
          <p:cNvSpPr txBox="1"/>
          <p:nvPr/>
        </p:nvSpPr>
        <p:spPr>
          <a:xfrm>
            <a:off x="0" y="0"/>
            <a:ext cx="6858000" cy="95410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: 8 VOCs included in cox LASSO.</a:t>
            </a:r>
            <a:b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itter boxplot graph for each metabolite included in the cox LASSO model. The centre line is the median; box limits are upper and lower quartiles; whiskers are 1.5x interquartile range; points are individual observations.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F68A58A-F375-48C4-88C3-ECB214FE2D20}"/>
              </a:ext>
            </a:extLst>
          </p:cNvPr>
          <p:cNvGrpSpPr/>
          <p:nvPr/>
        </p:nvGrpSpPr>
        <p:grpSpPr>
          <a:xfrm>
            <a:off x="4811152" y="7279430"/>
            <a:ext cx="2034656" cy="1600438"/>
            <a:chOff x="4811152" y="7279430"/>
            <a:chExt cx="2034656" cy="1600438"/>
          </a:xfrm>
        </p:grpSpPr>
        <p:sp>
          <p:nvSpPr>
            <p:cNvPr id="15" name="Arrow: Down 14">
              <a:extLst>
                <a:ext uri="{FF2B5EF4-FFF2-40B4-BE49-F238E27FC236}">
                  <a16:creationId xmlns:a16="http://schemas.microsoft.com/office/drawing/2014/main" id="{848BFB4C-4B5C-4FE3-B12C-211C7338A82F}"/>
                </a:ext>
              </a:extLst>
            </p:cNvPr>
            <p:cNvSpPr/>
            <p:nvPr/>
          </p:nvSpPr>
          <p:spPr>
            <a:xfrm rot="10800000">
              <a:off x="4811152" y="7333891"/>
              <a:ext cx="276548" cy="237968"/>
            </a:xfrm>
            <a:prstGeom prst="downArrow">
              <a:avLst/>
            </a:prstGeom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A5577DF-F8CD-41DA-9610-BD1AFD08477D}"/>
                </a:ext>
              </a:extLst>
            </p:cNvPr>
            <p:cNvSpPr txBox="1"/>
            <p:nvPr/>
          </p:nvSpPr>
          <p:spPr>
            <a:xfrm>
              <a:off x="5094060" y="7279430"/>
              <a:ext cx="1751748" cy="16004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rend to increase towards death.</a:t>
              </a:r>
            </a:p>
            <a:p>
              <a:endParaRPr lang="en-GB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endParaRPr lang="en-GB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endParaRPr lang="en-GB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r>
                <a:rPr lang="en-GB" sz="14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rend to decrease towards death. </a:t>
              </a:r>
              <a:endParaRPr lang="en-GB" sz="1400" dirty="0"/>
            </a:p>
          </p:txBody>
        </p:sp>
        <p:sp>
          <p:nvSpPr>
            <p:cNvPr id="17" name="Arrow: Down 16">
              <a:extLst>
                <a:ext uri="{FF2B5EF4-FFF2-40B4-BE49-F238E27FC236}">
                  <a16:creationId xmlns:a16="http://schemas.microsoft.com/office/drawing/2014/main" id="{2932B42D-8079-4077-A738-740C0F652283}"/>
                </a:ext>
              </a:extLst>
            </p:cNvPr>
            <p:cNvSpPr/>
            <p:nvPr/>
          </p:nvSpPr>
          <p:spPr>
            <a:xfrm>
              <a:off x="4829704" y="8500962"/>
              <a:ext cx="276548" cy="237968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9AFBC03E-E5D8-48B8-BD1C-0C6B78E4B8D1}"/>
              </a:ext>
            </a:extLst>
          </p:cNvPr>
          <p:cNvSpPr/>
          <p:nvPr/>
        </p:nvSpPr>
        <p:spPr>
          <a:xfrm>
            <a:off x="4742688" y="7193280"/>
            <a:ext cx="2037797" cy="17800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73550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9B9F474-DD48-474A-B455-374D3AAC1B5A}"/>
              </a:ext>
            </a:extLst>
          </p:cNvPr>
          <p:cNvSpPr txBox="1"/>
          <p:nvPr/>
        </p:nvSpPr>
        <p:spPr>
          <a:xfrm>
            <a:off x="1" y="0"/>
            <a:ext cx="6858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6: </a:t>
            </a:r>
            <a:r>
              <a:rPr lang="en-GB" sz="14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 PCA score plot for the data sets deemed of high quality, as the QC data points (pooled samples) cluster tightly in comparison to the total variance in the projection. A. </a:t>
            </a:r>
            <a:r>
              <a:rPr lang="en-GB" sz="14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4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id dataset: 205 patient samples, 31 pooled samples B. Alkali dataset: 150 patient samples, 28 pooled samples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Chart, scatter chart&#10;&#10;Description automatically generated">
            <a:extLst>
              <a:ext uri="{FF2B5EF4-FFF2-40B4-BE49-F238E27FC236}">
                <a16:creationId xmlns:a16="http://schemas.microsoft.com/office/drawing/2014/main" id="{75FDE749-6072-443E-8AB7-0D49421E01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6837" y="1537835"/>
            <a:ext cx="5634896" cy="3566943"/>
          </a:xfrm>
          <a:prstGeom prst="rect">
            <a:avLst/>
          </a:prstGeom>
        </p:spPr>
      </p:pic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27F64E7D-2CAE-4C4E-9133-0878DF529AD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269" y="5561905"/>
            <a:ext cx="5758464" cy="432432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6998417-D48A-4382-80C7-30D59E773659}"/>
              </a:ext>
            </a:extLst>
          </p:cNvPr>
          <p:cNvSpPr txBox="1"/>
          <p:nvPr/>
        </p:nvSpPr>
        <p:spPr>
          <a:xfrm>
            <a:off x="6253134" y="2998792"/>
            <a:ext cx="785638" cy="6177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n = 205 </a:t>
            </a:r>
          </a:p>
          <a:p>
            <a:pPr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n = 3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5FBCBBF-71A8-4A2E-9C60-9629FF1A2D23}"/>
              </a:ext>
            </a:extLst>
          </p:cNvPr>
          <p:cNvSpPr txBox="1"/>
          <p:nvPr/>
        </p:nvSpPr>
        <p:spPr>
          <a:xfrm>
            <a:off x="6219013" y="7389524"/>
            <a:ext cx="785638" cy="6177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n = 150 </a:t>
            </a:r>
          </a:p>
          <a:p>
            <a:pPr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n = 2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2D74E9-3E37-456C-819C-50CB68603D8B}"/>
              </a:ext>
            </a:extLst>
          </p:cNvPr>
          <p:cNvSpPr txBox="1"/>
          <p:nvPr/>
        </p:nvSpPr>
        <p:spPr>
          <a:xfrm>
            <a:off x="-1" y="1224356"/>
            <a:ext cx="7951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. Aci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2FF8E6C-A7D9-4008-83FB-FB699BC2130F}"/>
              </a:ext>
            </a:extLst>
          </p:cNvPr>
          <p:cNvSpPr txBox="1"/>
          <p:nvPr/>
        </p:nvSpPr>
        <p:spPr>
          <a:xfrm>
            <a:off x="30931" y="5348684"/>
            <a:ext cx="8849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. Alkali</a:t>
            </a:r>
          </a:p>
        </p:txBody>
      </p:sp>
    </p:spTree>
    <p:extLst>
      <p:ext uri="{BB962C8B-B14F-4D97-AF65-F5344CB8AC3E}">
        <p14:creationId xmlns:p14="http://schemas.microsoft.com/office/powerpoint/2010/main" val="1598473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52</TotalTime>
  <Words>318</Words>
  <Application>Microsoft Office PowerPoint</Application>
  <PresentationFormat>A4 Paper (210x297 mm)</PresentationFormat>
  <Paragraphs>2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nor Chapman</dc:creator>
  <cp:lastModifiedBy>Elinor Chapman (Staff)</cp:lastModifiedBy>
  <cp:revision>81</cp:revision>
  <dcterms:created xsi:type="dcterms:W3CDTF">2022-10-30T16:48:25Z</dcterms:created>
  <dcterms:modified xsi:type="dcterms:W3CDTF">2023-01-11T11:22:32Z</dcterms:modified>
</cp:coreProperties>
</file>